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6" autoAdjust="0"/>
    <p:restoredTop sz="94660"/>
  </p:normalViewPr>
  <p:slideViewPr>
    <p:cSldViewPr snapToGrid="0">
      <p:cViewPr varScale="1">
        <p:scale>
          <a:sx n="162" d="100"/>
          <a:sy n="162" d="100"/>
        </p:scale>
        <p:origin x="184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A0B696-7859-4EC1-A519-8063250698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F52E3E1-97EB-4C2A-AD15-5624711904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2935FC-A24C-4EDD-AB4A-F9AF88ABE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CD66BE-3937-46FF-89AA-7CE372AB7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180D28-8969-488C-972D-C31850C62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3814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E3E8A8-60E5-44C9-BE36-A03C43C4BA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F5D55B1-B8A2-4CC9-944E-CFF13B8735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DB70E0-6466-4A55-8711-E10356B34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CB71BD-D02B-45A5-A35A-C3E50E7A1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40AF46-F040-48C6-8EDB-C005E798E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068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31B11E7-4DA6-4627-8A81-E0BC4BF155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5A09EBD-5BF1-4D0E-BE48-010CB04E6A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630981-EB96-45A6-AB5B-66EBBF13A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9B487E-FBCC-4CDE-BDAC-E817B5EC1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845273-99D5-4B5A-8B87-3D19D27EC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897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453144-1E3B-43B1-A37A-BE41415A8C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429DCF-5CE9-4A07-A435-8D2DDC0655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E3CC04-FDE2-4840-BA96-35045539E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87D178-ED18-45F2-BE82-EBC945CCE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E5349C-BC34-4E19-A1D4-A72AB19F1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025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F5498F-B100-44DE-94C3-1F64A18B05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B9A6B2-3D0B-4B4B-889F-3849967B84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F4A69A-77E3-4E37-9125-E16B15D8C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659D7C-974D-4057-97CF-B803B3EBE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E76DC1-2147-41EC-BB0B-9D30A013D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5974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C28B14-682B-4BD8-A235-9A4DB67F28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B59AC6A-C340-4607-888E-A1ED2EB0E5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3C803A5-C34C-4AD9-8494-B63AD20C43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267D9E2-5F58-48CB-BE61-3AEFFDE95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8B9864-D007-4DDC-84B3-1875E9052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6C4A79E-15FD-43F4-BCCD-46E1BCD7C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862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0F9388-F099-451C-BBD2-A17756D1E9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F91D23-32DB-4959-9756-91F4D21DF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0BFE4EA-D3DB-4320-8EE6-650E72614B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87400F7-7CD3-4ECA-B93F-FD867F76EC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E976320-F088-42ED-8159-5BC6963A58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3043590-C847-49F1-86C3-29FFE3883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623F5C9-C065-4283-9E8E-F73398B6E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5EED3C7-7671-4E43-89D3-45B3937A0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203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C43AAE-567F-4ACF-9836-B6D6077483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75D5A4D-6BC6-4B8B-AB63-6F6DE361C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CAE1715-99E4-4653-8F9D-67665CAAE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7AE3871-0FBF-4FE2-B627-5A7F84996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8303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62B5A12-7338-4A00-9B4F-F2283270D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DFBD5BF-0FB6-4866-AEAB-FC059824F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4333DCE-C377-4C2E-98E9-771D25BAF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3234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0A97CA-0D84-43B7-AC06-D9FE880AB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3B87E9-35AE-4C5C-B0AA-879F7E402D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BB6C410-21CC-4129-BD99-A8037E99BE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6FA486B-7489-44D1-8B0F-6328042A5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5C0A17-7FF2-491F-B909-100098864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9EA884-031C-456F-9935-318BC7571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326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9565CC-A06C-40C7-8CD8-A4D02BFD42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CAAB81F-B69F-4FD0-A02A-57A2DE6A0A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0228B3E-3447-4B4C-8517-C5B1BDEE40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548515-C854-4101-A9B1-884524F14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9602FD-FD49-41CE-9471-DDBC6A1D20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5CFE28-B0BE-4734-9C4E-9B85846C5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104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B4C9201-D464-4D46-A7E4-860791FFDE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704A8F-1525-4765-80FF-A1C4DB1F11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735455-BBF2-47D4-A8EE-1C50C0D578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727499-805B-49B1-B15A-1961605618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72361D-412E-4B48-A7DC-47AE318FD4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343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663EB4FE-73E5-4858-AFA6-0B9C6335A366}"/>
              </a:ext>
            </a:extLst>
          </p:cNvPr>
          <p:cNvGrpSpPr/>
          <p:nvPr/>
        </p:nvGrpSpPr>
        <p:grpSpPr>
          <a:xfrm>
            <a:off x="72869" y="547599"/>
            <a:ext cx="11979551" cy="4684543"/>
            <a:chOff x="72869" y="1327244"/>
            <a:chExt cx="11979551" cy="4684543"/>
          </a:xfrm>
        </p:grpSpPr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3666BC9C-8876-4293-8C4D-C4255AA2EC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11" t="24935" r="27957" b="32874"/>
            <a:stretch/>
          </p:blipFill>
          <p:spPr>
            <a:xfrm>
              <a:off x="72869" y="1667436"/>
              <a:ext cx="2814557" cy="4317928"/>
            </a:xfrm>
            <a:prstGeom prst="rect">
              <a:avLst/>
            </a:prstGeom>
          </p:spPr>
        </p:pic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B0019508-1D63-40B1-9777-6863F3936BB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01561" y="1682878"/>
              <a:ext cx="2784935" cy="4317926"/>
            </a:xfrm>
            <a:prstGeom prst="rect">
              <a:avLst/>
            </a:prstGeom>
          </p:spPr>
        </p:pic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6CC9C5DA-2D0D-40FE-98D0-101E4BA58C1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0493" y="1667438"/>
              <a:ext cx="2784935" cy="4317926"/>
            </a:xfrm>
            <a:prstGeom prst="rect">
              <a:avLst/>
            </a:prstGeom>
          </p:spPr>
        </p:pic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068813C5-7002-4AD8-B585-484A70E6F41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72629" y="1667438"/>
              <a:ext cx="2784935" cy="4317926"/>
            </a:xfrm>
            <a:prstGeom prst="rect">
              <a:avLst/>
            </a:prstGeom>
          </p:spPr>
        </p:pic>
        <p:pic>
          <p:nvPicPr>
            <p:cNvPr id="28" name="図 27">
              <a:extLst>
                <a:ext uri="{FF2B5EF4-FFF2-40B4-BE49-F238E27FC236}">
                  <a16:creationId xmlns:a16="http://schemas.microsoft.com/office/drawing/2014/main" id="{EAD64B2D-1E9A-47FF-8D5F-1641EFA27639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72774" y="1673787"/>
              <a:ext cx="72000" cy="4338000"/>
            </a:xfrm>
            <a:prstGeom prst="rect">
              <a:avLst/>
            </a:prstGeom>
          </p:spPr>
        </p:pic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EE29EAB0-09B1-4C22-A741-9372974EC0CD}"/>
                </a:ext>
              </a:extLst>
            </p:cNvPr>
            <p:cNvSpPr txBox="1"/>
            <p:nvPr/>
          </p:nvSpPr>
          <p:spPr>
            <a:xfrm rot="16200000">
              <a:off x="10941026" y="3672511"/>
              <a:ext cx="13712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radioactivity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A4149B87-7E91-4456-9D9D-4DA1FD31D07E}"/>
                </a:ext>
              </a:extLst>
            </p:cNvPr>
            <p:cNvSpPr txBox="1"/>
            <p:nvPr/>
          </p:nvSpPr>
          <p:spPr>
            <a:xfrm>
              <a:off x="11508681" y="1589710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DC915B59-77CF-44E8-8A09-7515B90DE8EB}"/>
                </a:ext>
              </a:extLst>
            </p:cNvPr>
            <p:cNvSpPr txBox="1"/>
            <p:nvPr/>
          </p:nvSpPr>
          <p:spPr>
            <a:xfrm>
              <a:off x="11526728" y="5704010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37909DD6-25E5-4DF8-AC75-DA201EB85300}"/>
                </a:ext>
              </a:extLst>
            </p:cNvPr>
            <p:cNvSpPr txBox="1"/>
            <p:nvPr/>
          </p:nvSpPr>
          <p:spPr>
            <a:xfrm>
              <a:off x="3749727" y="1327244"/>
              <a:ext cx="11464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 h lighting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A4C153EF-5302-4221-9B02-3342CDAAB1E6}"/>
                </a:ext>
              </a:extLst>
            </p:cNvPr>
            <p:cNvSpPr txBox="1"/>
            <p:nvPr/>
          </p:nvSpPr>
          <p:spPr>
            <a:xfrm>
              <a:off x="6620795" y="1327244"/>
              <a:ext cx="11464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5 h lighting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7EF79B1C-2CE6-4663-AC59-D4ED09AEBE39}"/>
                </a:ext>
              </a:extLst>
            </p:cNvPr>
            <p:cNvSpPr txBox="1"/>
            <p:nvPr/>
          </p:nvSpPr>
          <p:spPr>
            <a:xfrm>
              <a:off x="9559190" y="1327244"/>
              <a:ext cx="10118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 h lighting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4D6EE51E-FEE7-49EC-8E2D-2DBB85646826}"/>
                </a:ext>
              </a:extLst>
            </p:cNvPr>
            <p:cNvSpPr txBox="1"/>
            <p:nvPr/>
          </p:nvSpPr>
          <p:spPr>
            <a:xfrm>
              <a:off x="404791" y="1327244"/>
              <a:ext cx="21210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eld of view of the PETIS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71EC349-D1D2-4393-84EE-2812B865FFA0}"/>
              </a:ext>
            </a:extLst>
          </p:cNvPr>
          <p:cNvSpPr txBox="1"/>
          <p:nvPr/>
        </p:nvSpPr>
        <p:spPr>
          <a:xfrm>
            <a:off x="0" y="5770103"/>
            <a:ext cx="121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nimation of </a:t>
            </a:r>
            <a:r>
              <a:rPr kumimoji="1"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photoynshtae translocation to strawberry fruits of Plant B in 0.5 h, 4.5 h and 9 h lighting treatments.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8857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45</Words>
  <Application>Microsoft Office PowerPoint</Application>
  <PresentationFormat>ワイド画面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悠 悠</dc:creator>
  <cp:lastModifiedBy>Yuta Miyoshi</cp:lastModifiedBy>
  <cp:revision>11</cp:revision>
  <dcterms:created xsi:type="dcterms:W3CDTF">2021-03-28T23:34:59Z</dcterms:created>
  <dcterms:modified xsi:type="dcterms:W3CDTF">2021-03-31T10:11:59Z</dcterms:modified>
</cp:coreProperties>
</file>